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1"/>
  </p:sldMasterIdLst>
  <p:sldIdLst>
    <p:sldId id="259" r:id="rId2"/>
  </p:sldIdLst>
  <p:sldSz cx="14400213" cy="19799300"/>
  <p:notesSz cx="6858000" cy="9144000"/>
  <p:defaultTextStyle>
    <a:defPPr>
      <a:defRPr lang="en-US"/>
    </a:defPPr>
    <a:lvl1pPr marL="0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1pPr>
    <a:lvl2pPr marL="820765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2pPr>
    <a:lvl3pPr marL="1641531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3pPr>
    <a:lvl4pPr marL="2462296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4pPr>
    <a:lvl5pPr marL="3283062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5pPr>
    <a:lvl6pPr marL="4103827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6pPr>
    <a:lvl7pPr marL="4924593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7pPr>
    <a:lvl8pPr marL="5745358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8pPr>
    <a:lvl9pPr marL="6566124" algn="l" defTabSz="820765" rtl="0" eaLnBrk="1" latinLnBrk="0" hangingPunct="1">
      <a:defRPr sz="323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16A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094"/>
    <p:restoredTop sz="91429"/>
  </p:normalViewPr>
  <p:slideViewPr>
    <p:cSldViewPr snapToGrid="0" snapToObjects="1">
      <p:cViewPr varScale="1">
        <p:scale>
          <a:sx n="15" d="100"/>
          <a:sy n="15" d="100"/>
        </p:scale>
        <p:origin x="1552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/Users/Baker/Documents/Shigella/Sonnei/SouthCentralAmerica/JUSTWRITEIT/Supplementary_Table_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2389568846549"/>
          <c:y val="0.0257827287551945"/>
          <c:w val="0.881353376521806"/>
          <c:h val="0.71886124800889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esistance_phenotype over time'!$A$28</c:f>
              <c:strCache>
                <c:ptCount val="1"/>
                <c:pt idx="0">
                  <c:v>1997 - 1999 (n=28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Resistance_phenotype over time'!$B$27:$I$27</c:f>
              <c:strCache>
                <c:ptCount val="8"/>
                <c:pt idx="0">
                  <c:v>Aminoglycoside</c:v>
                </c:pt>
                <c:pt idx="1">
                  <c:v>Beta-lactam</c:v>
                </c:pt>
                <c:pt idx="2">
                  <c:v>Phenicol</c:v>
                </c:pt>
                <c:pt idx="3">
                  <c:v>Trimethoprim</c:v>
                </c:pt>
                <c:pt idx="4">
                  <c:v>Sulphonamide</c:v>
                </c:pt>
                <c:pt idx="5">
                  <c:v>Tetracycline</c:v>
                </c:pt>
                <c:pt idx="6">
                  <c:v>Macrolide</c:v>
                </c:pt>
                <c:pt idx="7">
                  <c:v>Quinolone</c:v>
                </c:pt>
              </c:strCache>
            </c:strRef>
          </c:cat>
          <c:val>
            <c:numRef>
              <c:f>'Resistance_phenotype over time'!$B$28:$I$28</c:f>
              <c:numCache>
                <c:formatCode>General</c:formatCode>
                <c:ptCount val="8"/>
                <c:pt idx="0">
                  <c:v>0.964285714285714</c:v>
                </c:pt>
                <c:pt idx="1">
                  <c:v>0.75</c:v>
                </c:pt>
                <c:pt idx="2">
                  <c:v>0.571428571428571</c:v>
                </c:pt>
                <c:pt idx="3">
                  <c:v>0.857142857142857</c:v>
                </c:pt>
                <c:pt idx="4">
                  <c:v>0.714285714285714</c:v>
                </c:pt>
                <c:pt idx="5">
                  <c:v>0.714285714285714</c:v>
                </c:pt>
                <c:pt idx="6">
                  <c:v>0.0</c:v>
                </c:pt>
                <c:pt idx="7">
                  <c:v>0.0</c:v>
                </c:pt>
              </c:numCache>
            </c:numRef>
          </c:val>
        </c:ser>
        <c:ser>
          <c:idx val="1"/>
          <c:order val="1"/>
          <c:tx>
            <c:strRef>
              <c:f>'Resistance_phenotype over time'!$A$29</c:f>
              <c:strCache>
                <c:ptCount val="1"/>
                <c:pt idx="0">
                  <c:v>2000 - 2002 (n=40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Resistance_phenotype over time'!$B$27:$I$27</c:f>
              <c:strCache>
                <c:ptCount val="8"/>
                <c:pt idx="0">
                  <c:v>Aminoglycoside</c:v>
                </c:pt>
                <c:pt idx="1">
                  <c:v>Beta-lactam</c:v>
                </c:pt>
                <c:pt idx="2">
                  <c:v>Phenicol</c:v>
                </c:pt>
                <c:pt idx="3">
                  <c:v>Trimethoprim</c:v>
                </c:pt>
                <c:pt idx="4">
                  <c:v>Sulphonamide</c:v>
                </c:pt>
                <c:pt idx="5">
                  <c:v>Tetracycline</c:v>
                </c:pt>
                <c:pt idx="6">
                  <c:v>Macrolide</c:v>
                </c:pt>
                <c:pt idx="7">
                  <c:v>Quinolone</c:v>
                </c:pt>
              </c:strCache>
            </c:strRef>
          </c:cat>
          <c:val>
            <c:numRef>
              <c:f>'Resistance_phenotype over time'!$B$29:$I$29</c:f>
              <c:numCache>
                <c:formatCode>General</c:formatCode>
                <c:ptCount val="8"/>
                <c:pt idx="0">
                  <c:v>0.85</c:v>
                </c:pt>
                <c:pt idx="1">
                  <c:v>0.5</c:v>
                </c:pt>
                <c:pt idx="2">
                  <c:v>0.025</c:v>
                </c:pt>
                <c:pt idx="3">
                  <c:v>0.85</c:v>
                </c:pt>
                <c:pt idx="4">
                  <c:v>0.275</c:v>
                </c:pt>
                <c:pt idx="5">
                  <c:v>0.475</c:v>
                </c:pt>
                <c:pt idx="6">
                  <c:v>0.0</c:v>
                </c:pt>
                <c:pt idx="7">
                  <c:v>0.0</c:v>
                </c:pt>
              </c:numCache>
            </c:numRef>
          </c:val>
        </c:ser>
        <c:ser>
          <c:idx val="2"/>
          <c:order val="2"/>
          <c:tx>
            <c:strRef>
              <c:f>'Resistance_phenotype over time'!$A$30</c:f>
              <c:strCache>
                <c:ptCount val="1"/>
                <c:pt idx="0">
                  <c:v>2003 - 2005 (n=44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Resistance_phenotype over time'!$B$27:$I$27</c:f>
              <c:strCache>
                <c:ptCount val="8"/>
                <c:pt idx="0">
                  <c:v>Aminoglycoside</c:v>
                </c:pt>
                <c:pt idx="1">
                  <c:v>Beta-lactam</c:v>
                </c:pt>
                <c:pt idx="2">
                  <c:v>Phenicol</c:v>
                </c:pt>
                <c:pt idx="3">
                  <c:v>Trimethoprim</c:v>
                </c:pt>
                <c:pt idx="4">
                  <c:v>Sulphonamide</c:v>
                </c:pt>
                <c:pt idx="5">
                  <c:v>Tetracycline</c:v>
                </c:pt>
                <c:pt idx="6">
                  <c:v>Macrolide</c:v>
                </c:pt>
                <c:pt idx="7">
                  <c:v>Quinolone</c:v>
                </c:pt>
              </c:strCache>
            </c:strRef>
          </c:cat>
          <c:val>
            <c:numRef>
              <c:f>'Resistance_phenotype over time'!$B$30:$I$30</c:f>
              <c:numCache>
                <c:formatCode>General</c:formatCode>
                <c:ptCount val="8"/>
                <c:pt idx="0">
                  <c:v>0.568181818181818</c:v>
                </c:pt>
                <c:pt idx="1">
                  <c:v>0.363636363636364</c:v>
                </c:pt>
                <c:pt idx="2">
                  <c:v>0.0681818181818182</c:v>
                </c:pt>
                <c:pt idx="3">
                  <c:v>0.590909090909091</c:v>
                </c:pt>
                <c:pt idx="4">
                  <c:v>0.613636363636364</c:v>
                </c:pt>
                <c:pt idx="5">
                  <c:v>0.386363636363636</c:v>
                </c:pt>
                <c:pt idx="6">
                  <c:v>0.0</c:v>
                </c:pt>
                <c:pt idx="7">
                  <c:v>0.0</c:v>
                </c:pt>
              </c:numCache>
            </c:numRef>
          </c:val>
        </c:ser>
        <c:ser>
          <c:idx val="3"/>
          <c:order val="3"/>
          <c:tx>
            <c:strRef>
              <c:f>'Resistance_phenotype over time'!$A$31</c:f>
              <c:strCache>
                <c:ptCount val="1"/>
                <c:pt idx="0">
                  <c:v>2006 - 2008 (n=53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Resistance_phenotype over time'!$B$27:$I$27</c:f>
              <c:strCache>
                <c:ptCount val="8"/>
                <c:pt idx="0">
                  <c:v>Aminoglycoside</c:v>
                </c:pt>
                <c:pt idx="1">
                  <c:v>Beta-lactam</c:v>
                </c:pt>
                <c:pt idx="2">
                  <c:v>Phenicol</c:v>
                </c:pt>
                <c:pt idx="3">
                  <c:v>Trimethoprim</c:v>
                </c:pt>
                <c:pt idx="4">
                  <c:v>Sulphonamide</c:v>
                </c:pt>
                <c:pt idx="5">
                  <c:v>Tetracycline</c:v>
                </c:pt>
                <c:pt idx="6">
                  <c:v>Macrolide</c:v>
                </c:pt>
                <c:pt idx="7">
                  <c:v>Quinolone</c:v>
                </c:pt>
              </c:strCache>
            </c:strRef>
          </c:cat>
          <c:val>
            <c:numRef>
              <c:f>'Resistance_phenotype over time'!$B$31:$I$31</c:f>
              <c:numCache>
                <c:formatCode>General</c:formatCode>
                <c:ptCount val="8"/>
                <c:pt idx="0">
                  <c:v>0.849056603773585</c:v>
                </c:pt>
                <c:pt idx="1">
                  <c:v>0.528301886792453</c:v>
                </c:pt>
                <c:pt idx="2">
                  <c:v>0.150943396226415</c:v>
                </c:pt>
                <c:pt idx="3">
                  <c:v>0.886792452830189</c:v>
                </c:pt>
                <c:pt idx="4">
                  <c:v>0.773584905660377</c:v>
                </c:pt>
                <c:pt idx="5">
                  <c:v>0.679245283018868</c:v>
                </c:pt>
                <c:pt idx="6">
                  <c:v>0.0</c:v>
                </c:pt>
                <c:pt idx="7">
                  <c:v>0.0</c:v>
                </c:pt>
              </c:numCache>
            </c:numRef>
          </c:val>
        </c:ser>
        <c:ser>
          <c:idx val="4"/>
          <c:order val="4"/>
          <c:tx>
            <c:strRef>
              <c:f>'Resistance_phenotype over time'!$A$32</c:f>
              <c:strCache>
                <c:ptCount val="1"/>
                <c:pt idx="0">
                  <c:v>2009 - 2011 (n=109)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Resistance_phenotype over time'!$B$27:$I$27</c:f>
              <c:strCache>
                <c:ptCount val="8"/>
                <c:pt idx="0">
                  <c:v>Aminoglycoside</c:v>
                </c:pt>
                <c:pt idx="1">
                  <c:v>Beta-lactam</c:v>
                </c:pt>
                <c:pt idx="2">
                  <c:v>Phenicol</c:v>
                </c:pt>
                <c:pt idx="3">
                  <c:v>Trimethoprim</c:v>
                </c:pt>
                <c:pt idx="4">
                  <c:v>Sulphonamide</c:v>
                </c:pt>
                <c:pt idx="5">
                  <c:v>Tetracycline</c:v>
                </c:pt>
                <c:pt idx="6">
                  <c:v>Macrolide</c:v>
                </c:pt>
                <c:pt idx="7">
                  <c:v>Quinolone</c:v>
                </c:pt>
              </c:strCache>
            </c:strRef>
          </c:cat>
          <c:val>
            <c:numRef>
              <c:f>'Resistance_phenotype over time'!$B$32:$I$32</c:f>
              <c:numCache>
                <c:formatCode>General</c:formatCode>
                <c:ptCount val="8"/>
                <c:pt idx="0">
                  <c:v>0.834862385321101</c:v>
                </c:pt>
                <c:pt idx="1">
                  <c:v>0.495412844036697</c:v>
                </c:pt>
                <c:pt idx="2">
                  <c:v>0.403669724770642</c:v>
                </c:pt>
                <c:pt idx="3">
                  <c:v>0.788990825688073</c:v>
                </c:pt>
                <c:pt idx="4">
                  <c:v>0.752293577981651</c:v>
                </c:pt>
                <c:pt idx="5">
                  <c:v>0.724770642201835</c:v>
                </c:pt>
                <c:pt idx="6">
                  <c:v>0.0091743119266055</c:v>
                </c:pt>
                <c:pt idx="7">
                  <c:v>0.0091743119266055</c:v>
                </c:pt>
              </c:numCache>
            </c:numRef>
          </c:val>
        </c:ser>
        <c:ser>
          <c:idx val="5"/>
          <c:order val="5"/>
          <c:tx>
            <c:strRef>
              <c:f>'Resistance_phenotype over time'!$A$33</c:f>
              <c:strCache>
                <c:ptCount val="1"/>
                <c:pt idx="0">
                  <c:v>2012 - 2014 (n=33)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Resistance_phenotype over time'!$B$27:$I$27</c:f>
              <c:strCache>
                <c:ptCount val="8"/>
                <c:pt idx="0">
                  <c:v>Aminoglycoside</c:v>
                </c:pt>
                <c:pt idx="1">
                  <c:v>Beta-lactam</c:v>
                </c:pt>
                <c:pt idx="2">
                  <c:v>Phenicol</c:v>
                </c:pt>
                <c:pt idx="3">
                  <c:v>Trimethoprim</c:v>
                </c:pt>
                <c:pt idx="4">
                  <c:v>Sulphonamide</c:v>
                </c:pt>
                <c:pt idx="5">
                  <c:v>Tetracycline</c:v>
                </c:pt>
                <c:pt idx="6">
                  <c:v>Macrolide</c:v>
                </c:pt>
                <c:pt idx="7">
                  <c:v>Quinolone</c:v>
                </c:pt>
              </c:strCache>
            </c:strRef>
          </c:cat>
          <c:val>
            <c:numRef>
              <c:f>'Resistance_phenotype over time'!$B$33:$I$33</c:f>
              <c:numCache>
                <c:formatCode>General</c:formatCode>
                <c:ptCount val="8"/>
                <c:pt idx="0">
                  <c:v>0.848484848484848</c:v>
                </c:pt>
                <c:pt idx="1">
                  <c:v>0.151515151515152</c:v>
                </c:pt>
                <c:pt idx="2">
                  <c:v>0.0303030303030303</c:v>
                </c:pt>
                <c:pt idx="3">
                  <c:v>0.878787878787879</c:v>
                </c:pt>
                <c:pt idx="4">
                  <c:v>0.757575757575757</c:v>
                </c:pt>
                <c:pt idx="5">
                  <c:v>0.757575757575757</c:v>
                </c:pt>
                <c:pt idx="6">
                  <c:v>0.0</c:v>
                </c:pt>
                <c:pt idx="7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79"/>
        <c:overlap val="-27"/>
        <c:axId val="-1525195920"/>
        <c:axId val="-1525429824"/>
      </c:barChart>
      <c:catAx>
        <c:axId val="-15251959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2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000" smtClean="0"/>
                  <a:t>Antimicrobial class</a:t>
                </a:r>
              </a:p>
            </c:rich>
          </c:tx>
          <c:layout>
            <c:manualLayout>
              <c:xMode val="edge"/>
              <c:yMode val="edge"/>
              <c:x val="0.446907160043961"/>
              <c:y val="0.8323775695423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2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525429824"/>
        <c:crosses val="autoZero"/>
        <c:auto val="1"/>
        <c:lblAlgn val="ctr"/>
        <c:lblOffset val="100"/>
        <c:noMultiLvlLbl val="0"/>
      </c:catAx>
      <c:valAx>
        <c:axId val="-1525429824"/>
        <c:scaling>
          <c:orientation val="minMax"/>
          <c:max val="1.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000" dirty="0" smtClean="0"/>
                  <a:t>Predicted resistant phenotypes</a:t>
                </a:r>
                <a:r>
                  <a:rPr lang="en-US" sz="2000" baseline="0" dirty="0" smtClean="0"/>
                  <a:t> (proportion) </a:t>
                </a:r>
                <a:endParaRPr lang="en-US" sz="2000" dirty="0"/>
              </a:p>
            </c:rich>
          </c:tx>
          <c:layout>
            <c:manualLayout>
              <c:xMode val="edge"/>
              <c:yMode val="edge"/>
              <c:x val="0.0152167000434185"/>
              <c:y val="0.13831082154498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5251959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12166318484408"/>
          <c:y val="0.0134331367892483"/>
          <c:w val="0.178607714929578"/>
          <c:h val="0.31730365083368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00027" y="3240303"/>
            <a:ext cx="10800160" cy="6893090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10399217"/>
            <a:ext cx="10800160" cy="4780246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0EA64-D806-43AC-9DF2-F8C432F32B4C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72561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9C37B-1D36-470B-8223-D6C91242EC14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0856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2" y="1054129"/>
            <a:ext cx="3105046" cy="1677899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1054129"/>
            <a:ext cx="9135135" cy="1677899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6F52A-A82B-47A2-A83A-8C4C91F2D59F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388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0A7B3-6521-4DCA-87E5-044747A908C1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49541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4" y="4936079"/>
            <a:ext cx="12420184" cy="8235957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4" y="13249951"/>
            <a:ext cx="12420184" cy="4331095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0EA64-D806-43AC-9DF2-F8C432F32B4C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72442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5270647"/>
            <a:ext cx="6120091" cy="1256247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5270647"/>
            <a:ext cx="6120091" cy="1256247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34690-1557-4C89-A502-4959FE7FAD70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60424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054131"/>
            <a:ext cx="12420184" cy="382694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1" y="4853580"/>
            <a:ext cx="6091965" cy="2378664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1" y="7232244"/>
            <a:ext cx="6091965" cy="1063754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8" y="4853580"/>
            <a:ext cx="6121966" cy="2378664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8" y="7232244"/>
            <a:ext cx="6121966" cy="1063754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D4976-E339-4826-83B7-FBD03F55ECF8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8995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37C31-9E7A-4F99-8774-A0E530DE1A42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93738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8504F-A551-4DE0-9316-4DCD1D8CC752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66386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1" y="1319953"/>
            <a:ext cx="4644443" cy="4619837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2850734"/>
            <a:ext cx="7290108" cy="14070336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1" y="5939790"/>
            <a:ext cx="4644443" cy="11004196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E4249-C0D0-4B06-8692-E8BB871AF643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09614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1" y="1319953"/>
            <a:ext cx="4644443" cy="4619837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6121966" y="2850734"/>
            <a:ext cx="7290108" cy="14070336"/>
          </a:xfrm>
        </p:spPr>
        <p:txBody>
          <a:bodyPr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1" y="5939790"/>
            <a:ext cx="4644443" cy="11004196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0DB6-F5C7-45FB-8CF3-31B45F9C2DAC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6979-0714-4377-B894-6BE4C2D6E20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21324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1054131"/>
            <a:ext cx="12420184" cy="382694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5270647"/>
            <a:ext cx="12420184" cy="125624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8351020"/>
            <a:ext cx="3240048" cy="10541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60EA64-D806-43AC-9DF2-F8C432F32B4C}" type="datetimeFigureOut">
              <a:rPr lang="en-US" smtClean="0"/>
              <a:t>3/16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8351020"/>
            <a:ext cx="4860072" cy="10541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8351020"/>
            <a:ext cx="3240048" cy="10541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7A6979-0714-4377-B894-6BE4C2D6E20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827151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hf sldNum="0" hdr="0" ftr="0" dt="0"/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19403332"/>
              </p:ext>
            </p:extLst>
          </p:nvPr>
        </p:nvGraphicFramePr>
        <p:xfrm>
          <a:off x="0" y="517583"/>
          <a:ext cx="14199005" cy="80445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660150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72</TotalTime>
  <Words>8</Words>
  <Application>Microsoft Macintosh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ker, Kate</dc:creator>
  <cp:lastModifiedBy>Microsoft Office User</cp:lastModifiedBy>
  <cp:revision>66</cp:revision>
  <dcterms:created xsi:type="dcterms:W3CDTF">2016-08-18T08:45:32Z</dcterms:created>
  <dcterms:modified xsi:type="dcterms:W3CDTF">2017-03-16T12:19:13Z</dcterms:modified>
</cp:coreProperties>
</file>